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8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205" y="478971"/>
            <a:ext cx="6123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3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utlier strains and expression data*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2263867"/>
              </p:ext>
            </p:extLst>
          </p:nvPr>
        </p:nvGraphicFramePr>
        <p:xfrm>
          <a:off x="397046" y="985213"/>
          <a:ext cx="6235249" cy="7092411"/>
        </p:xfrm>
        <a:graphic>
          <a:graphicData uri="http://schemas.openxmlformats.org/drawingml/2006/table">
            <a:tbl>
              <a:tblPr/>
              <a:tblGrid>
                <a:gridCol w="6561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369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82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838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403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921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0761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3762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file 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ertion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t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ertion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x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ientation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P Express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erry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xpressi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CL068C(HML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5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CL067C(HML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6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S1-2(rDNA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001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N37-2(rDNA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296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N37-2(rDNA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073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6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omere 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DR542W(telomere 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3540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H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3561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8A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1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2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403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2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256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S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44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C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889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1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B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483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O4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543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2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TP5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776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4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254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KS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660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K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6705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3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506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M2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60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WC2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579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H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410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S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110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13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49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L081W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286</a:t>
                      </a:r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I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0720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1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O1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783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O2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429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R12(</a:t>
                      </a:r>
                      <a:r>
                        <a:rPr lang="en-US" sz="11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955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9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L1(</a:t>
                      </a:r>
                      <a:r>
                        <a:rPr lang="en-US" sz="11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7742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3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8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O10(</a:t>
                      </a:r>
                      <a:r>
                        <a:rPr lang="en-US" sz="11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492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1.288	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9</a:t>
                      </a: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03520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23(</a:t>
                      </a:r>
                      <a:r>
                        <a:rPr lang="en-US" sz="11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u</a:t>
                      </a:r>
                      <a:r>
                        <a:rPr lang="en-US" sz="11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8486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3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0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76" marR="6076" marT="607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2321" y="8348804"/>
            <a:ext cx="6123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* Green rows: GFP outliers; red: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outlier; purple: GFP and </a:t>
            </a:r>
            <a:r>
              <a:rPr lang="en-US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outliers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9270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299</Words>
  <Application>Microsoft Office PowerPoint</Application>
  <PresentationFormat>Letter Paper (8.5x11 in)</PresentationFormat>
  <Paragraphs>2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3</cp:revision>
  <cp:lastPrinted>2016-12-22T22:05:19Z</cp:lastPrinted>
  <dcterms:created xsi:type="dcterms:W3CDTF">2016-06-14T18:48:14Z</dcterms:created>
  <dcterms:modified xsi:type="dcterms:W3CDTF">2017-03-30T15:37:10Z</dcterms:modified>
</cp:coreProperties>
</file>